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6" r:id="rId2"/>
    <p:sldId id="267" r:id="rId3"/>
    <p:sldId id="263" r:id="rId4"/>
    <p:sldId id="262" r:id="rId5"/>
    <p:sldId id="269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262" autoAdjust="0"/>
  </p:normalViewPr>
  <p:slideViewPr>
    <p:cSldViewPr snapToGrid="0">
      <p:cViewPr varScale="1">
        <p:scale>
          <a:sx n="75" d="100"/>
          <a:sy n="75" d="100"/>
        </p:scale>
        <p:origin x="893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53A093-42C3-485E-9482-B477343759AF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FD5330C-353A-4243-A772-3682E6FA15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49950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FD5330C-353A-4243-A772-3682E6FA15D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418610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FD5330C-353A-4243-A772-3682E6FA15DA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2218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FD5330C-353A-4243-A772-3682E6FA15DA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512466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FD5330C-353A-4243-A772-3682E6FA15DA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33580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FD5330C-353A-4243-A772-3682E6FA15DA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34709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2A1F24-2719-5D66-92BB-8AA2965383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6400AFB-6F8E-E7ED-E369-54ED403E1BD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ED0317-D32A-1B40-9FFF-74320FADAB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439B7-F10C-4452-B7FD-B31B177B768D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42BE87-DED0-050E-01C2-9FD29ADC47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A569DE-DBBF-9E4F-642A-5937EE1B88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60B65-3D79-486A-BB6F-513398534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1811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DEA3AB-73C4-F3AA-2108-FD5CAD58EC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31F5D4-88C3-F161-96E0-536F4BB6E7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2DBF87-7E85-0314-BBB3-87CDA2F91D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439B7-F10C-4452-B7FD-B31B177B768D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7A9A42-0502-1681-6E03-4502CA1B4A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B352D6-2A5A-B369-B3FD-33E3B15EB3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60B65-3D79-486A-BB6F-513398534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11082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9114D4E-9A49-73B0-D85D-7E42202B6E5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E38B2D9-ED12-444B-5215-00479D9061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FB7D52-85A2-34E2-9036-F3B704CDCE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439B7-F10C-4452-B7FD-B31B177B768D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F5EFDB-5C1F-B08E-E23E-42B8756480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2FCAB1-C540-AD22-0117-09F69AA47C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60B65-3D79-486A-BB6F-513398534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38497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E82975-8D05-65E2-BE45-90850580A5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6DF2AA-20F1-979E-4A1E-9004FF9275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D5F0D8-BD11-5025-3A80-1EC31CF263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439B7-F10C-4452-B7FD-B31B177B768D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318ABA-28B5-8F57-21CF-7979391EF8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955461-9A5F-60B2-A940-D58A3714E5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60B65-3D79-486A-BB6F-513398534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81776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93874D-61DB-0CCA-122A-407200DC69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292FEA-16B3-B3FB-44FB-DCD5AC2758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830E0D-8A43-1E6E-5D43-0C0832F528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439B7-F10C-4452-B7FD-B31B177B768D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DA7A6F-FAC3-D4C9-C984-60FF4F85CF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7F788C-8DEE-4B95-261C-4C6394B5C9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60B65-3D79-486A-BB6F-513398534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6682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CEB6F1-F656-E7CA-E522-13FEA85659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27A632D-F870-334F-1412-96121A3A5FA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1463919-3FFA-E4CC-E937-F8639217BA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2A45F45-F772-838C-68FB-ECE0B1B746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439B7-F10C-4452-B7FD-B31B177B768D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8CA123-CA31-4640-323B-0AF0FE69AC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1BE5A6-4B92-C9E4-59CE-1A8CCBDEF0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60B65-3D79-486A-BB6F-513398534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96137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195DDC-53ED-014D-9200-AA875DA182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B783520-740F-9734-315E-07B1FBBA0C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91" y="1681165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BF2E36-E290-1CBB-E451-1C6FFE8E41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91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7A5436E-1E67-489C-51C0-666F53BD19D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5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AA22F8E-E4C0-7CBB-B216-8CF99931D66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1420E9C-AA9C-FF58-832F-CE6369ECBD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439B7-F10C-4452-B7FD-B31B177B768D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FF88103-39ED-12F6-4551-97DF1244A7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E626EA0-835A-CFCA-D731-BAA1E4E245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60B65-3D79-486A-BB6F-513398534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29759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AC8CDC-CDD9-8BCA-BC73-B5A3C8D04A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22A2E2F-58EE-CBAC-AA4B-682FFB32A1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439B7-F10C-4452-B7FD-B31B177B768D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9E8E642-216A-6987-ED13-D4B506C1FB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A709D6F-F87A-8BC2-11F6-EEB88A2D3A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60B65-3D79-486A-BB6F-513398534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89741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698B385-07EF-13C5-FB8C-6A9387EC02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439B7-F10C-4452-B7FD-B31B177B768D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7CB4373-930F-20FD-13FE-5F3F67CA54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ADA5CE1-C74A-86F6-3A7D-B492C6BC75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60B65-3D79-486A-BB6F-513398534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67266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48B15C-211D-4401-DA26-CE4247C8D1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2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30FC22-6AF6-CB3C-9A68-CF69B4CF6E9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F346A9C-196D-BBA0-45BE-317F0C3F01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2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B955BB-07CE-2529-56E9-AE1659C298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439B7-F10C-4452-B7FD-B31B177B768D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6C85280-A552-17F6-EB0E-73C2F1EE08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B2E7EF3-7BF2-35BF-7B15-6109DDF27B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60B65-3D79-486A-BB6F-513398534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32922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E6BB5F-D654-7BC3-7E8D-77E48977B0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2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79C0AA7-17B8-5A9A-5BC3-DEEB40E0464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44A070D-B47D-45B9-1D62-D087F0683A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2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88C494-8805-5C5E-96A6-C6A3AEF1CB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439B7-F10C-4452-B7FD-B31B177B768D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09B60F-09AA-223A-BCF9-BE1B4CF739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6B2ACF-A15D-6956-F66C-24A7A40120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60B65-3D79-486A-BB6F-513398534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32340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BBF1FAA-660D-0ECE-60A6-AC898AA973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72D4AE-BF85-2200-F3C8-F606F60C9D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7D695E-04C1-7F2E-61A6-3EFABA8FDBE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D439B7-F10C-4452-B7FD-B31B177B768D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F853E4-EDB1-32CD-33DA-B1E96D6D0F8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2818A6-569A-183F-CEBC-70820ED8FA3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760B65-3D79-486A-BB6F-5133985349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93780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0699527-FAD7-3EC2-E0CE-3448C9C1D004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16561"/>
          <a:stretch/>
        </p:blipFill>
        <p:spPr>
          <a:xfrm>
            <a:off x="76074" y="1402080"/>
            <a:ext cx="5908166" cy="480426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1C20E2FC-66AE-F3D0-84C7-791B462BDFA6}"/>
              </a:ext>
            </a:extLst>
          </p:cNvPr>
          <p:cNvSpPr/>
          <p:nvPr/>
        </p:nvSpPr>
        <p:spPr>
          <a:xfrm>
            <a:off x="3789680" y="1523999"/>
            <a:ext cx="2194560" cy="914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5654FAEF-09D7-15E9-E8FD-B7E6C28CCC57}"/>
              </a:ext>
            </a:extLst>
          </p:cNvPr>
          <p:cNvSpPr/>
          <p:nvPr/>
        </p:nvSpPr>
        <p:spPr>
          <a:xfrm>
            <a:off x="9921366" y="1432558"/>
            <a:ext cx="2194560" cy="18288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B54BB75B-972B-B63F-C679-E38972065CD9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r="8409"/>
          <a:stretch/>
        </p:blipFill>
        <p:spPr>
          <a:xfrm>
            <a:off x="6042078" y="1402082"/>
            <a:ext cx="6149922" cy="4804263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6D7B5F7-A671-12F4-6FFF-9F858295434E}"/>
              </a:ext>
            </a:extLst>
          </p:cNvPr>
          <p:cNvSpPr txBox="1"/>
          <p:nvPr/>
        </p:nvSpPr>
        <p:spPr>
          <a:xfrm>
            <a:off x="-1669835" y="1515953"/>
            <a:ext cx="148274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figure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60699E9-6065-C71A-EF19-D85D2FFFF174}"/>
              </a:ext>
            </a:extLst>
          </p:cNvPr>
          <p:cNvSpPr txBox="1"/>
          <p:nvPr/>
        </p:nvSpPr>
        <p:spPr>
          <a:xfrm>
            <a:off x="0" y="1293465"/>
            <a:ext cx="3555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/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CD9D588-FB56-2371-8902-27C4EAF25C97}"/>
              </a:ext>
            </a:extLst>
          </p:cNvPr>
          <p:cNvSpPr txBox="1"/>
          <p:nvPr/>
        </p:nvSpPr>
        <p:spPr>
          <a:xfrm>
            <a:off x="6030012" y="1293465"/>
            <a:ext cx="3555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/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56AB69B-8814-4865-295B-5D717A1F8F8E}"/>
              </a:ext>
            </a:extLst>
          </p:cNvPr>
          <p:cNvSpPr txBox="1"/>
          <p:nvPr/>
        </p:nvSpPr>
        <p:spPr>
          <a:xfrm>
            <a:off x="0" y="177329"/>
            <a:ext cx="11930231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sz="2000" dirty="0">
                <a:solidFill>
                  <a:srgbClr val="FF0000"/>
                </a:solidFill>
              </a:rPr>
              <a:t>Figure1</a:t>
            </a:r>
            <a:r>
              <a:rPr lang="en-US" sz="2000" dirty="0"/>
              <a:t>. (A) Cellular component enrichment analysis of genes with downregulated expression in type 1 Gaucher disease among individuals over 50 years old. (B) Cellular component enrichment analysis of genes with upregulated expression in type 1 Gaucher disease among individuals over 50 years old. </a:t>
            </a:r>
          </a:p>
          <a:p>
            <a:endParaRPr lang="en-US" sz="20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336593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A44AD2C-8A38-6B1A-4341-12BA9947E52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1E312A8E-A5FF-3C12-971A-B8C7742EF1F0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6283"/>
          <a:stretch/>
        </p:blipFill>
        <p:spPr>
          <a:xfrm>
            <a:off x="6239555" y="1473200"/>
            <a:ext cx="5893390" cy="480426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3417CC77-7A8C-9CD1-205D-988A31056907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r="8169"/>
          <a:stretch/>
        </p:blipFill>
        <p:spPr>
          <a:xfrm>
            <a:off x="137286" y="1473200"/>
            <a:ext cx="6035040" cy="480426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A3C5D65-2F7D-145C-2630-9BAB1C6ECD4D}"/>
              </a:ext>
            </a:extLst>
          </p:cNvPr>
          <p:cNvSpPr txBox="1"/>
          <p:nvPr/>
        </p:nvSpPr>
        <p:spPr>
          <a:xfrm>
            <a:off x="70057" y="1694466"/>
            <a:ext cx="3555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F7EC73A-5745-05E1-D720-19BA676BC005}"/>
              </a:ext>
            </a:extLst>
          </p:cNvPr>
          <p:cNvSpPr txBox="1"/>
          <p:nvPr/>
        </p:nvSpPr>
        <p:spPr>
          <a:xfrm>
            <a:off x="6172326" y="1402079"/>
            <a:ext cx="3555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/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679ABAE-3038-9208-0389-0DC6D0D9CAFC}"/>
              </a:ext>
            </a:extLst>
          </p:cNvPr>
          <p:cNvSpPr txBox="1"/>
          <p:nvPr/>
        </p:nvSpPr>
        <p:spPr>
          <a:xfrm>
            <a:off x="-1669835" y="1515953"/>
            <a:ext cx="148274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figure5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A316C2C-B454-A3B6-DDB3-486755008F62}"/>
              </a:ext>
            </a:extLst>
          </p:cNvPr>
          <p:cNvSpPr txBox="1"/>
          <p:nvPr/>
        </p:nvSpPr>
        <p:spPr>
          <a:xfrm>
            <a:off x="274320" y="191540"/>
            <a:ext cx="1184762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Figure 2. </a:t>
            </a:r>
            <a:r>
              <a:rPr lang="en-US" dirty="0"/>
              <a:t>(A) Cellular component enrichment analysis of genes with downregulated expression in type 1 Gaucher disease among individuals under 50 years old. (B) Cellular component enrichment analysis of genes with upregulated expression in type 1 Gaucher disease among individuals under 50 years old.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007007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82A3D44-76C0-6B80-723D-AE8A0E44918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>
            <a:extLst>
              <a:ext uri="{FF2B5EF4-FFF2-40B4-BE49-F238E27FC236}">
                <a16:creationId xmlns:a16="http://schemas.microsoft.com/office/drawing/2014/main" id="{D87A3FC8-A4C3-8336-9F43-AAB670758620}"/>
              </a:ext>
            </a:extLst>
          </p:cNvPr>
          <p:cNvGrpSpPr/>
          <p:nvPr/>
        </p:nvGrpSpPr>
        <p:grpSpPr>
          <a:xfrm>
            <a:off x="5850609" y="790043"/>
            <a:ext cx="6238240" cy="5053872"/>
            <a:chOff x="71120" y="944880"/>
            <a:chExt cx="6238240" cy="5053872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291F4F59-F595-31DD-5E59-FE22A7B2436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1120" y="944880"/>
              <a:ext cx="6238240" cy="5053872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107BA6FA-7670-6ED8-108B-C11BB0614EEE}"/>
                </a:ext>
              </a:extLst>
            </p:cNvPr>
            <p:cNvSpPr/>
            <p:nvPr/>
          </p:nvSpPr>
          <p:spPr>
            <a:xfrm>
              <a:off x="3728720" y="953425"/>
              <a:ext cx="2540000" cy="15645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F7F8DC4C-69C0-FE7B-6DD0-DE06C97205DB}"/>
              </a:ext>
            </a:extLst>
          </p:cNvPr>
          <p:cNvGrpSpPr/>
          <p:nvPr/>
        </p:nvGrpSpPr>
        <p:grpSpPr>
          <a:xfrm>
            <a:off x="45970" y="790043"/>
            <a:ext cx="5762799" cy="5053872"/>
            <a:chOff x="6365792" y="1598036"/>
            <a:chExt cx="5762799" cy="4023360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4247CF1A-5859-94CF-71CE-F5407636AF4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r="9087"/>
            <a:stretch/>
          </p:blipFill>
          <p:spPr>
            <a:xfrm>
              <a:off x="6365792" y="1598036"/>
              <a:ext cx="5762799" cy="402336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02FD055C-4132-020A-51C4-6D3A603B20DD}"/>
                </a:ext>
              </a:extLst>
            </p:cNvPr>
            <p:cNvSpPr/>
            <p:nvPr/>
          </p:nvSpPr>
          <p:spPr>
            <a:xfrm>
              <a:off x="10261600" y="2316479"/>
              <a:ext cx="1859280" cy="14535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8B801444-646B-F9A0-73B7-D9C94A92917F}"/>
              </a:ext>
            </a:extLst>
          </p:cNvPr>
          <p:cNvSpPr txBox="1"/>
          <p:nvPr/>
        </p:nvSpPr>
        <p:spPr>
          <a:xfrm>
            <a:off x="-1669835" y="1515953"/>
            <a:ext cx="148274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figure8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C3721B6-5A3F-3A02-160A-80B0F78EC944}"/>
              </a:ext>
            </a:extLst>
          </p:cNvPr>
          <p:cNvSpPr txBox="1"/>
          <p:nvPr/>
        </p:nvSpPr>
        <p:spPr>
          <a:xfrm>
            <a:off x="0" y="736897"/>
            <a:ext cx="3555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0AB7A51-ED52-7C84-4739-033C99F6CACA}"/>
              </a:ext>
            </a:extLst>
          </p:cNvPr>
          <p:cNvSpPr txBox="1"/>
          <p:nvPr/>
        </p:nvSpPr>
        <p:spPr>
          <a:xfrm>
            <a:off x="5808769" y="731381"/>
            <a:ext cx="3555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/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0DEB627-7547-06F8-E861-6282CE497F6F}"/>
              </a:ext>
            </a:extLst>
          </p:cNvPr>
          <p:cNvSpPr txBox="1"/>
          <p:nvPr/>
        </p:nvSpPr>
        <p:spPr>
          <a:xfrm>
            <a:off x="103151" y="81280"/>
            <a:ext cx="1178404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>
                <a:solidFill>
                  <a:srgbClr val="FF0000"/>
                </a:solidFill>
              </a:rPr>
              <a:t>Figure 3. </a:t>
            </a:r>
            <a:r>
              <a:rPr lang="en-US" dirty="0"/>
              <a:t>(A) Cellular component enrichment analysis of genes with downregulated expression in type 2 Gaucher disease. (B) Cellular component enrichment analysis of genes with upregulated expression in type 2 Gaucher disease. </a:t>
            </a:r>
          </a:p>
        </p:txBody>
      </p:sp>
    </p:spTree>
    <p:extLst>
      <p:ext uri="{BB962C8B-B14F-4D97-AF65-F5344CB8AC3E}">
        <p14:creationId xmlns:p14="http://schemas.microsoft.com/office/powerpoint/2010/main" val="30112029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26B4BC15-A2B2-DE09-FF6E-20055966FD1E}"/>
              </a:ext>
            </a:extLst>
          </p:cNvPr>
          <p:cNvGrpSpPr/>
          <p:nvPr/>
        </p:nvGrpSpPr>
        <p:grpSpPr>
          <a:xfrm>
            <a:off x="50805" y="1435925"/>
            <a:ext cx="6045195" cy="4538154"/>
            <a:chOff x="50801" y="1435925"/>
            <a:chExt cx="6228077" cy="4538154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110167DB-0DF6-621F-170A-FA4C66B4B23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r="11484"/>
            <a:stretch/>
          </p:blipFill>
          <p:spPr>
            <a:xfrm>
              <a:off x="50801" y="1435925"/>
              <a:ext cx="6226752" cy="4538154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EEF458B6-AB57-E863-F214-B8C4C11095DE}"/>
                </a:ext>
              </a:extLst>
            </p:cNvPr>
            <p:cNvSpPr/>
            <p:nvPr/>
          </p:nvSpPr>
          <p:spPr>
            <a:xfrm>
              <a:off x="3901438" y="1541758"/>
              <a:ext cx="2377440" cy="13208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083357E9-C7ED-CC05-BA46-8FED22844EB1}"/>
              </a:ext>
            </a:extLst>
          </p:cNvPr>
          <p:cNvGrpSpPr/>
          <p:nvPr/>
        </p:nvGrpSpPr>
        <p:grpSpPr>
          <a:xfrm>
            <a:off x="6181726" y="1435925"/>
            <a:ext cx="5936612" cy="4538154"/>
            <a:chOff x="30480" y="1173480"/>
            <a:chExt cx="6022338" cy="4470400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EA959A23-B800-C398-264B-C29586901F9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r="3329"/>
            <a:stretch/>
          </p:blipFill>
          <p:spPr>
            <a:xfrm>
              <a:off x="30480" y="1173480"/>
              <a:ext cx="6020459" cy="44704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7901D76D-5315-366C-D52E-AAC12D11A1C2}"/>
                </a:ext>
              </a:extLst>
            </p:cNvPr>
            <p:cNvSpPr/>
            <p:nvPr/>
          </p:nvSpPr>
          <p:spPr>
            <a:xfrm>
              <a:off x="3766818" y="1370171"/>
              <a:ext cx="2286000" cy="13208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500F9724-8781-1FC3-1717-35CC4843F191}"/>
              </a:ext>
            </a:extLst>
          </p:cNvPr>
          <p:cNvSpPr txBox="1"/>
          <p:nvPr/>
        </p:nvSpPr>
        <p:spPr>
          <a:xfrm>
            <a:off x="-1669835" y="1515953"/>
            <a:ext cx="148274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figure1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51662C3-8CBA-F4F6-E9BB-EC713AEF740F}"/>
              </a:ext>
            </a:extLst>
          </p:cNvPr>
          <p:cNvSpPr txBox="1"/>
          <p:nvPr/>
        </p:nvSpPr>
        <p:spPr>
          <a:xfrm>
            <a:off x="48953" y="1268198"/>
            <a:ext cx="3555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/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3871D1E-654C-914B-A025-4379615F2104}"/>
              </a:ext>
            </a:extLst>
          </p:cNvPr>
          <p:cNvSpPr txBox="1"/>
          <p:nvPr/>
        </p:nvSpPr>
        <p:spPr>
          <a:xfrm>
            <a:off x="6154864" y="1673838"/>
            <a:ext cx="3555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/>
              <a:t>B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438A00B-30D3-B159-13F7-7D52FE15EDA2}"/>
              </a:ext>
            </a:extLst>
          </p:cNvPr>
          <p:cNvSpPr txBox="1"/>
          <p:nvPr/>
        </p:nvSpPr>
        <p:spPr>
          <a:xfrm>
            <a:off x="47101" y="101600"/>
            <a:ext cx="11870579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>
                <a:solidFill>
                  <a:srgbClr val="FF0000"/>
                </a:solidFill>
              </a:rPr>
              <a:t>Figure 4. </a:t>
            </a:r>
            <a:r>
              <a:rPr lang="en-US" dirty="0"/>
              <a:t>(A) Cellular component enrichment analysis of genes with downregulated expression in type 3 Gaucher disease among individuals over 5 years old. (B) Cellular component enrichment analysis of genes with upregulated expression in type 3 Gaucher disease among individuals over 5 years old. </a:t>
            </a:r>
          </a:p>
        </p:txBody>
      </p:sp>
    </p:spTree>
    <p:extLst>
      <p:ext uri="{BB962C8B-B14F-4D97-AF65-F5344CB8AC3E}">
        <p14:creationId xmlns:p14="http://schemas.microsoft.com/office/powerpoint/2010/main" val="376822772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D671418-92A4-C5C9-134D-FD2A4732825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84CCE4E1-E6B6-FA58-A6D4-B94922FA6355}"/>
              </a:ext>
            </a:extLst>
          </p:cNvPr>
          <p:cNvGrpSpPr/>
          <p:nvPr/>
        </p:nvGrpSpPr>
        <p:grpSpPr>
          <a:xfrm>
            <a:off x="6096000" y="1341596"/>
            <a:ext cx="6020459" cy="4538154"/>
            <a:chOff x="6096000" y="1173480"/>
            <a:chExt cx="6020459" cy="4470400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2425C41B-219A-2A20-A957-1FFC14D0177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r="11895"/>
            <a:stretch/>
          </p:blipFill>
          <p:spPr>
            <a:xfrm>
              <a:off x="6096000" y="1173480"/>
              <a:ext cx="6020459" cy="44704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DEE2DF48-AE36-C5E8-FB5D-4D8A79524E9A}"/>
                </a:ext>
              </a:extLst>
            </p:cNvPr>
            <p:cNvSpPr/>
            <p:nvPr/>
          </p:nvSpPr>
          <p:spPr>
            <a:xfrm>
              <a:off x="9830459" y="1341596"/>
              <a:ext cx="2286000" cy="13208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12" name="Picture 11">
            <a:extLst>
              <a:ext uri="{FF2B5EF4-FFF2-40B4-BE49-F238E27FC236}">
                <a16:creationId xmlns:a16="http://schemas.microsoft.com/office/drawing/2014/main" id="{22D02F77-482B-D761-731B-FB5E5CA5A762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r="5703"/>
          <a:stretch/>
        </p:blipFill>
        <p:spPr>
          <a:xfrm>
            <a:off x="117429" y="1341596"/>
            <a:ext cx="5779858" cy="453815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63426AA-8235-4EF2-EF5B-9B0A81D36F79}"/>
              </a:ext>
            </a:extLst>
          </p:cNvPr>
          <p:cNvSpPr txBox="1"/>
          <p:nvPr/>
        </p:nvSpPr>
        <p:spPr>
          <a:xfrm>
            <a:off x="-1669835" y="1515953"/>
            <a:ext cx="148274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figure1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205F8A6-7173-62B4-E97A-BAABDD289291}"/>
              </a:ext>
            </a:extLst>
          </p:cNvPr>
          <p:cNvSpPr txBox="1"/>
          <p:nvPr/>
        </p:nvSpPr>
        <p:spPr>
          <a:xfrm>
            <a:off x="777290" y="1227980"/>
            <a:ext cx="3555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4A447EC-5D8E-65F5-2C7B-CA9D02DFD44C}"/>
              </a:ext>
            </a:extLst>
          </p:cNvPr>
          <p:cNvSpPr txBox="1"/>
          <p:nvPr/>
        </p:nvSpPr>
        <p:spPr>
          <a:xfrm>
            <a:off x="6096000" y="1227980"/>
            <a:ext cx="3555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/>
              <a:t>B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0713CEC-8D27-3031-C785-5AE6CB092F93}"/>
              </a:ext>
            </a:extLst>
          </p:cNvPr>
          <p:cNvSpPr txBox="1"/>
          <p:nvPr/>
        </p:nvSpPr>
        <p:spPr>
          <a:xfrm>
            <a:off x="117429" y="0"/>
            <a:ext cx="11957142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Figure 5. </a:t>
            </a:r>
            <a:r>
              <a:rPr lang="en-US" dirty="0"/>
              <a:t>(A) Cellular component enrichment analysis of genes with downregulated expression in type 3 Gaucher disease among individuals under 5 years old. (B) Cellular component enrichment analysis of genes with upregulated expression in type 3 Gaucher disease among individuals under 5 years old. </a:t>
            </a:r>
          </a:p>
        </p:txBody>
      </p:sp>
    </p:spTree>
    <p:extLst>
      <p:ext uri="{BB962C8B-B14F-4D97-AF65-F5344CB8AC3E}">
        <p14:creationId xmlns:p14="http://schemas.microsoft.com/office/powerpoint/2010/main" val="34077671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920</TotalTime>
  <Words>262</Words>
  <Application>Microsoft Office PowerPoint</Application>
  <PresentationFormat>Widescreen</PresentationFormat>
  <Paragraphs>25</Paragraphs>
  <Slides>5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ohammad</dc:creator>
  <cp:lastModifiedBy>mohammad</cp:lastModifiedBy>
  <cp:revision>51</cp:revision>
  <dcterms:created xsi:type="dcterms:W3CDTF">2025-03-16T07:02:23Z</dcterms:created>
  <dcterms:modified xsi:type="dcterms:W3CDTF">2025-09-18T13:30:53Z</dcterms:modified>
</cp:coreProperties>
</file>